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1522" y="-14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S25: 3D model structure and validation of </a:t>
            </a:r>
            <a:r>
              <a:rPr lang="en-US" sz="1600" dirty="0"/>
              <a:t>MTHFR</a:t>
            </a:r>
            <a:r>
              <a:rPr lang="en-GB" sz="1600" dirty="0" smtClean="0"/>
              <a:t> gene. A) Wild (Template </a:t>
            </a:r>
            <a:r>
              <a:rPr lang="en-US" sz="1600" dirty="0"/>
              <a:t>3apt_A</a:t>
            </a:r>
            <a:endParaRPr lang="en-GB" sz="1600" dirty="0"/>
          </a:p>
          <a:p>
            <a:pPr algn="ctr"/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3apt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142852"/>
            <a:ext cx="3143272" cy="27860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9700" y="134933"/>
            <a:ext cx="3517904" cy="293687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9220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2910" y="3143248"/>
            <a:ext cx="3143272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21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143248"/>
            <a:ext cx="3500462" cy="278608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3</cp:revision>
  <dcterms:created xsi:type="dcterms:W3CDTF">2018-05-10T07:33:24Z</dcterms:created>
  <dcterms:modified xsi:type="dcterms:W3CDTF">2018-05-29T05:50:23Z</dcterms:modified>
</cp:coreProperties>
</file>